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5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56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893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408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3620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44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398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2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068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530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8332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270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0266B-8114-4A19-871A-CD197518704C}" type="datetimeFigureOut">
              <a:rPr lang="en-GB" smtClean="0"/>
              <a:t>15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345403-BE64-4281-A531-EED122C1F6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6875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GB" dirty="0" smtClean="0"/>
              <a:t>Principal Components </a:t>
            </a:r>
            <a:r>
              <a:rPr lang="en-GB" dirty="0" smtClean="0"/>
              <a:t>Analysis and Neighbourhood Joining </a:t>
            </a:r>
            <a:r>
              <a:rPr lang="en-GB" dirty="0" err="1"/>
              <a:t>D</a:t>
            </a:r>
            <a:r>
              <a:rPr lang="en-GB" dirty="0" err="1" smtClean="0"/>
              <a:t>endrogram</a:t>
            </a:r>
            <a:r>
              <a:rPr lang="en-GB" dirty="0" smtClean="0"/>
              <a:t> on </a:t>
            </a:r>
            <a:r>
              <a:rPr lang="en-GB" dirty="0" smtClean="0"/>
              <a:t>Linear Mixed-Effects Model </a:t>
            </a:r>
            <a:br>
              <a:rPr lang="en-GB" dirty="0" smtClean="0"/>
            </a:br>
            <a:r>
              <a:rPr lang="en-GB" dirty="0" smtClean="0"/>
              <a:t>Coefficients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03648" y="4005064"/>
            <a:ext cx="6400800" cy="1752600"/>
          </a:xfrm>
        </p:spPr>
        <p:txBody>
          <a:bodyPr/>
          <a:lstStyle/>
          <a:p>
            <a:r>
              <a:rPr lang="en-GB" dirty="0" smtClean="0"/>
              <a:t>Appendix </a:t>
            </a:r>
            <a:r>
              <a:rPr lang="en-GB" dirty="0"/>
              <a:t>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36998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9211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85" y="0"/>
            <a:ext cx="903563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19672" y="548680"/>
            <a:ext cx="6552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Neighbour joining using Euclidean similarity on LME coefficients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4538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4</TotalTime>
  <Words>21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rincipal Components Analysis and Neighbourhood Joining Dendrogram on Linear Mixed-Effects Model  Coefficients</vt:lpstr>
      <vt:lpstr>PowerPoint Presentation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ncipal Components Analysis</dc:title>
  <dc:creator>James Bell (RRes-Roth)</dc:creator>
  <cp:lastModifiedBy>James Bell (RRes-Roth)</cp:lastModifiedBy>
  <cp:revision>7</cp:revision>
  <cp:lastPrinted>2014-01-15T14:52:27Z</cp:lastPrinted>
  <dcterms:created xsi:type="dcterms:W3CDTF">2013-12-11T12:43:43Z</dcterms:created>
  <dcterms:modified xsi:type="dcterms:W3CDTF">2014-01-17T10:48:08Z</dcterms:modified>
</cp:coreProperties>
</file>